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5BBE47-1D97-446D-82D2-6580D29056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0B1216-6751-4DFF-B260-994A19AA74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4E8AFA-0C88-4B1B-9DC9-2ED43DA00E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0407DE-3EFF-4EB3-8474-4C13FAB013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656CF2-6D28-4CCE-A5EC-61B44D5EE0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0BA1F-5243-4D48-B4B9-9E28E0505B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80818-E5EF-4D63-8727-E62D02F416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47C49-F552-4514-AF59-94BD0E867C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6CE000-EC7B-4C43-A0AB-78F0A9C4B9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0801CF-1164-4713-B2F1-0CBF61E776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287F0-33A6-4551-88DB-FA902DFE4A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912C3-C542-4776-A6B6-3AA6F9F2A1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A3DA4E-BFCB-4431-9260-F69EC23048A2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"/>
          <p:cNvSpPr/>
          <p:nvPr/>
        </p:nvSpPr>
        <p:spPr>
          <a:xfrm>
            <a:off x="257760" y="2916360"/>
            <a:ext cx="307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ble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2. Primer list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or real-time RT-PC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404640" y="3276720"/>
          <a:ext cx="6193080" cy="1495440"/>
        </p:xfrm>
        <a:graphic>
          <a:graphicData uri="http://schemas.openxmlformats.org/drawingml/2006/table">
            <a:tbl>
              <a:tblPr/>
              <a:tblGrid>
                <a:gridCol w="1227240"/>
                <a:gridCol w="2290680"/>
                <a:gridCol w="2675160"/>
              </a:tblGrid>
              <a:tr h="28656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rget ge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 (5'- 3'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 (5'- 3'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04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m_</a:t>
                      </a: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CCTTTCCACACACCTGAA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GATGCAAGGCCAATTTCTTGC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6828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8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unknow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GTAACAGATGCTAAACCTTCGGG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TACAGTAGGACGAATCCTTGTG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04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m_</a:t>
                      </a: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o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GTTCTGTTGTTCACTCAGAGG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GGGGTACCAATTCAGCGTCA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972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m_</a:t>
                      </a: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pz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AAACACAGCTCCACGCGGTA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GTTTCGTAGAAGTATCGGACCTT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5T07:42:36Z</dcterms:created>
  <dc:creator> </dc:creator>
  <dc:description/>
  <dc:language>en-US</dc:language>
  <cp:lastModifiedBy> </cp:lastModifiedBy>
  <dcterms:modified xsi:type="dcterms:W3CDTF">2011-08-10T05:37:15Z</dcterms:modified>
  <cp:revision>3</cp:revision>
  <dc:subject/>
  <dc:title>スライド 1</dc:title>
</cp:coreProperties>
</file>